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DAA8C4-6FFB-3FDF-14C2-12BEDE194C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F75AA90-5BE0-4765-F2D7-F6432896C3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180EC8-6071-9C81-38C1-7DBEEE98A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EA6DD3-F58C-D7A2-6C98-306D0EB33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57A2AE-0384-45D2-07D9-CD7F7CE3D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985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A4E64F-16D5-3E76-FD0F-412BF003A5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F66B018-52CA-C71E-53C4-4779F60D9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E0C19C-72A8-49A8-20F5-2F4915B30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F14888-2EEC-181B-A9B8-1CFD4FB8F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F727EE-ADF0-6F50-A0B5-3DAECD626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832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9115269-6909-9836-397A-999A49257D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3ADB09-A0F5-6F4D-7524-36ED520D92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389010-085E-04A6-38C2-7A0DF5E60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0D775B-A292-E6BD-44D5-A797C0664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2A397F-F961-6CB4-80E6-F1E82AACD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296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DCCA87-1F27-005D-E41B-0697C6555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FCDD916-E4D1-8EEC-F555-664250DB47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17B26F-6BD9-DFAF-1CC5-28649A458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B657EF-B0F0-F524-0F76-3BD7A9FA6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849889-8B3B-8677-80F8-19DF8DA5F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174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947774-318C-0C51-BD8A-78A0683F3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A697B2C-EACA-E41B-006F-F6AFB2FC5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C482F8-92A9-2945-EF99-D0B270EB3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35414C-4996-4D7C-A598-EC1C18BF3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E4BE98-48F5-6142-7AFC-DC2605C1E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157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A5F625-4C72-4FA1-4B7F-5AD0403064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B295849-FB67-C07B-528C-B714C43087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E32D125-604C-89E7-2E76-0DD9BEB26E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A90E8B9-44D2-66F2-4034-0E3EA6A4C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30E158-0FA3-A028-D7A5-7D36B3946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838A6A-744D-BB65-DAB1-2DB108114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885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A55F47-C93B-6316-1959-DDA9916AB7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3999AD5-7BB5-5763-6E3A-DF49DEAD1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5D51D7-8B10-7BF5-75E2-7B4162FDFD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B45603-F2FA-6D12-7B1A-919C9C879C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ED83C79-D014-90E0-7731-1841905034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0B3E1F8-B89B-6B5D-ACA2-4DCCE70FC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D5999B1-9B01-291F-AEEE-72BB803F2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1DF27A1-DC5A-53A1-49E2-E8ACB5420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1399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E7EBC5-9B9E-9980-6748-031283DAE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C494E78-249B-AF38-A2B9-8DD402B98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6CDC480-7B25-6C67-5A22-936D30DB3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E53D30F-1D05-98EA-5742-C6CC85D9E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432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91E9101-816B-B70A-7D72-B87494C3D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610C4E6-7115-52DB-91E2-0A2E6F2FB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805C089-E011-497A-EBED-6217C69A7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598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2B82E7-A34D-74A6-05B4-33C8034DC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ADAF22-A61F-379A-AAD4-50262A6919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99D8AAD-3222-2FAD-29B4-42509A224C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90543E-32E6-013B-6261-30395A7F5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37FD53D-BEFE-F86D-58E2-ACA2C29F5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6EB95E-1F8A-AB56-6B62-00F390066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9207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AB466C-81A9-777A-FF22-12A64971F4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5681556-E4D1-470F-FB52-6BA77FD419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42B3F2-77D8-66B5-C240-467A0BE0DF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F4B098-B63A-205A-36CB-1A005B45F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E4A714F-32FD-AE55-C4DF-74AE8A0CD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2FFFA6-87D2-B7DB-9D1B-EEFC949BD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273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8C44524-26C1-257F-0A2C-E97F3D857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18D5CA-F215-5729-494B-27F22714C0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9FCCDB-6278-0C7D-386F-2C260C3A86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C8FC3-1329-4451-94AD-B252EA843A57}" type="datetimeFigureOut">
              <a:rPr lang="zh-CN" altLang="en-US" smtClean="0"/>
              <a:t>2023/4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056C78-65EB-49DE-44BE-E0ED221B54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05EE19-B085-AE48-B175-D792AE4F2A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2E832-92FE-44DF-A156-DC18E6693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9610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ACE2AFDD-AEA7-706F-DA83-86B41E763254}"/>
              </a:ext>
            </a:extLst>
          </p:cNvPr>
          <p:cNvSpPr txBox="1"/>
          <p:nvPr/>
        </p:nvSpPr>
        <p:spPr>
          <a:xfrm flipH="1">
            <a:off x="279399" y="693398"/>
            <a:ext cx="217932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yro3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23 bp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62 bp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er: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6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：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74 b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F5221A8F-4EF2-128A-9C9A-F7B7EA015A2F}"/>
              </a:ext>
            </a:extLst>
          </p:cNvPr>
          <p:cNvGrpSpPr/>
          <p:nvPr/>
        </p:nvGrpSpPr>
        <p:grpSpPr>
          <a:xfrm>
            <a:off x="3316079" y="307318"/>
            <a:ext cx="7768480" cy="5804037"/>
            <a:chOff x="3316079" y="307318"/>
            <a:chExt cx="7768480" cy="5804037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60B739F1-A697-E818-70C3-11CDBD342607}"/>
                </a:ext>
              </a:extLst>
            </p:cNvPr>
            <p:cNvGrpSpPr/>
            <p:nvPr/>
          </p:nvGrpSpPr>
          <p:grpSpPr>
            <a:xfrm>
              <a:off x="3316079" y="307318"/>
              <a:ext cx="7768480" cy="5804037"/>
              <a:chOff x="3255120" y="652758"/>
              <a:chExt cx="7768480" cy="5804037"/>
            </a:xfrm>
          </p:grpSpPr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4B7086CC-9DA0-1B08-5DF6-747D4A2F4FAC}"/>
                  </a:ext>
                </a:extLst>
              </p:cNvPr>
              <p:cNvGrpSpPr/>
              <p:nvPr/>
            </p:nvGrpSpPr>
            <p:grpSpPr>
              <a:xfrm>
                <a:off x="3255120" y="652758"/>
                <a:ext cx="7768480" cy="5804037"/>
                <a:chOff x="3255120" y="652758"/>
                <a:chExt cx="7768480" cy="5804037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4117F4E6-E849-7A4E-E33E-3B2DFEB5AD3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55120" y="652758"/>
                  <a:ext cx="7768480" cy="5804037"/>
                </a:xfrm>
                <a:prstGeom prst="rect">
                  <a:avLst/>
                </a:prstGeom>
              </p:spPr>
            </p:pic>
            <p:sp>
              <p:nvSpPr>
                <p:cNvPr id="6" name="文本框 5">
                  <a:extLst>
                    <a:ext uri="{FF2B5EF4-FFF2-40B4-BE49-F238E27FC236}">
                      <a16:creationId xmlns:a16="http://schemas.microsoft.com/office/drawing/2014/main" id="{1C970655-F521-6FA1-A21A-3DA66676AFFB}"/>
                    </a:ext>
                  </a:extLst>
                </p:cNvPr>
                <p:cNvSpPr txBox="1"/>
                <p:nvPr/>
              </p:nvSpPr>
              <p:spPr>
                <a:xfrm>
                  <a:off x="4500100" y="5691600"/>
                  <a:ext cx="3881120" cy="2755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yro3                  Axl                    Mer</a:t>
                  </a:r>
                  <a:endParaRPr lang="zh-CN" alt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文本框 6">
                  <a:extLst>
                    <a:ext uri="{FF2B5EF4-FFF2-40B4-BE49-F238E27FC236}">
                      <a16:creationId xmlns:a16="http://schemas.microsoft.com/office/drawing/2014/main" id="{29F4D48C-BB9A-FCF4-7E1D-71084A62E92D}"/>
                    </a:ext>
                  </a:extLst>
                </p:cNvPr>
                <p:cNvSpPr txBox="1"/>
                <p:nvPr/>
              </p:nvSpPr>
              <p:spPr>
                <a:xfrm>
                  <a:off x="4216400" y="4561840"/>
                  <a:ext cx="403352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Mono 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Neu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        Mono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Neu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        Mon 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Neut</a:t>
                  </a:r>
                  <a:endParaRPr lang="zh-CN" altLang="en-US" sz="1100" b="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7D7A0CFF-B9EF-EB93-1139-E4FF3E4E1FA0}"/>
                    </a:ext>
                  </a:extLst>
                </p:cNvPr>
                <p:cNvSpPr txBox="1"/>
                <p:nvPr/>
              </p:nvSpPr>
              <p:spPr>
                <a:xfrm>
                  <a:off x="4226560" y="5496560"/>
                  <a:ext cx="403352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ko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 ko     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ko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 ko    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ko    </a:t>
                  </a:r>
                  <a:r>
                    <a:rPr lang="en-US" altLang="zh-CN" sz="1100" b="0" dirty="0" err="1">
                      <a:solidFill>
                        <a:schemeClr val="bg1"/>
                      </a:solidFill>
                    </a:rPr>
                    <a:t>wt</a:t>
                  </a:r>
                  <a:r>
                    <a:rPr lang="en-US" altLang="zh-CN" sz="1100" b="0" dirty="0">
                      <a:solidFill>
                        <a:schemeClr val="bg1"/>
                      </a:solidFill>
                    </a:rPr>
                    <a:t>  ko</a:t>
                  </a:r>
                  <a:endParaRPr lang="zh-CN" altLang="en-US" sz="1100" b="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2" name="直接连接符 11">
                  <a:extLst>
                    <a:ext uri="{FF2B5EF4-FFF2-40B4-BE49-F238E27FC236}">
                      <a16:creationId xmlns:a16="http://schemas.microsoft.com/office/drawing/2014/main" id="{6643E329-DBD1-1FEE-863E-6C6D31102F1E}"/>
                    </a:ext>
                  </a:extLst>
                </p:cNvPr>
                <p:cNvCxnSpPr/>
                <p:nvPr/>
              </p:nvCxnSpPr>
              <p:spPr>
                <a:xfrm>
                  <a:off x="4754880" y="4561840"/>
                  <a:ext cx="0" cy="119633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连接符 12">
                  <a:extLst>
                    <a:ext uri="{FF2B5EF4-FFF2-40B4-BE49-F238E27FC236}">
                      <a16:creationId xmlns:a16="http://schemas.microsoft.com/office/drawing/2014/main" id="{D2488BFC-84F9-2E80-2E23-65C12EE800BE}"/>
                    </a:ext>
                  </a:extLst>
                </p:cNvPr>
                <p:cNvCxnSpPr/>
                <p:nvPr/>
              </p:nvCxnSpPr>
              <p:spPr>
                <a:xfrm>
                  <a:off x="5902960" y="4572000"/>
                  <a:ext cx="0" cy="119633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接连接符 13">
                  <a:extLst>
                    <a:ext uri="{FF2B5EF4-FFF2-40B4-BE49-F238E27FC236}">
                      <a16:creationId xmlns:a16="http://schemas.microsoft.com/office/drawing/2014/main" id="{A2FDDB18-26B7-AAE9-6A05-0BB82315BE15}"/>
                    </a:ext>
                  </a:extLst>
                </p:cNvPr>
                <p:cNvCxnSpPr/>
                <p:nvPr/>
              </p:nvCxnSpPr>
              <p:spPr>
                <a:xfrm>
                  <a:off x="7051040" y="4572000"/>
                  <a:ext cx="0" cy="119633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30634491-4BD7-4804-7F66-011E89812108}"/>
                    </a:ext>
                  </a:extLst>
                </p:cNvPr>
                <p:cNvSpPr txBox="1"/>
                <p:nvPr/>
              </p:nvSpPr>
              <p:spPr>
                <a:xfrm>
                  <a:off x="7400289" y="1318209"/>
                  <a:ext cx="23190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2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>
                      <a:solidFill>
                        <a:schemeClr val="bg1"/>
                      </a:solidFill>
                    </a:rPr>
                    <a:t>Tyro3 β-actin       Axl β-actin</a:t>
                  </a:r>
                  <a:endParaRPr lang="zh-CN" altLang="en-US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21E503F0-615B-5AB8-D2D7-13D1D75671DB}"/>
                  </a:ext>
                </a:extLst>
              </p:cNvPr>
              <p:cNvSpPr txBox="1"/>
              <p:nvPr/>
            </p:nvSpPr>
            <p:spPr>
              <a:xfrm>
                <a:off x="8260081" y="4157877"/>
                <a:ext cx="1168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>
                    <a:solidFill>
                      <a:schemeClr val="bg1"/>
                    </a:solidFill>
                  </a:rPr>
                  <a:t>Mer β-actin  </a:t>
                </a:r>
                <a:endParaRPr lang="zh-CN" altLang="en-US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1724736C-DD6C-6345-B40F-806A391CCE03}"/>
                  </a:ext>
                </a:extLst>
              </p:cNvPr>
              <p:cNvSpPr txBox="1"/>
              <p:nvPr/>
            </p:nvSpPr>
            <p:spPr>
              <a:xfrm>
                <a:off x="4196080" y="2362228"/>
                <a:ext cx="55829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          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    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ko</a:t>
                </a:r>
                <a:endParaRPr lang="zh-CN" altLang="en-US" sz="1100" b="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7C613986-7FC4-B80E-13BB-3A25545BD820}"/>
                  </a:ext>
                </a:extLst>
              </p:cNvPr>
              <p:cNvSpPr txBox="1"/>
              <p:nvPr/>
            </p:nvSpPr>
            <p:spPr>
              <a:xfrm>
                <a:off x="8260080" y="5373477"/>
                <a:ext cx="1320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1100" b="0" dirty="0">
                    <a:solidFill>
                      <a:schemeClr val="bg1"/>
                    </a:solidFill>
                  </a:rPr>
                  <a:t>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 ko  </a:t>
                </a:r>
                <a:r>
                  <a:rPr lang="en-US" altLang="zh-CN" sz="1100" b="0" dirty="0" err="1">
                    <a:solidFill>
                      <a:schemeClr val="bg1"/>
                    </a:solidFill>
                  </a:rPr>
                  <a:t>wt</a:t>
                </a:r>
                <a:r>
                  <a:rPr lang="en-US" altLang="zh-CN" sz="1100" b="0" dirty="0">
                    <a:solidFill>
                      <a:schemeClr val="bg1"/>
                    </a:solidFill>
                  </a:rPr>
                  <a:t>  ko </a:t>
                </a:r>
                <a:endParaRPr lang="zh-CN" altLang="en-US" sz="1100" b="0" dirty="0">
                  <a:solidFill>
                    <a:schemeClr val="bg1"/>
                  </a:solidFill>
                </a:endParaRPr>
              </a:p>
            </p:txBody>
          </p:sp>
        </p:grpSp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19833801-80E4-F00C-A1AC-A115D5CD7670}"/>
                </a:ext>
              </a:extLst>
            </p:cNvPr>
            <p:cNvCxnSpPr/>
            <p:nvPr/>
          </p:nvCxnSpPr>
          <p:spPr>
            <a:xfrm>
              <a:off x="4307840" y="1837131"/>
              <a:ext cx="83312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D910EFF-2FE1-2864-FE64-610527EB7834}"/>
                </a:ext>
              </a:extLst>
            </p:cNvPr>
            <p:cNvSpPr txBox="1"/>
            <p:nvPr/>
          </p:nvSpPr>
          <p:spPr>
            <a:xfrm>
              <a:off x="4155440" y="1542370"/>
              <a:ext cx="1320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Tyro3 β-actin </a:t>
              </a:r>
              <a:endParaRPr lang="zh-CN" altLang="en-US" dirty="0"/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39982E86-7D14-2DC8-7CDB-ED59498D9A9E}"/>
                </a:ext>
              </a:extLst>
            </p:cNvPr>
            <p:cNvCxnSpPr/>
            <p:nvPr/>
          </p:nvCxnSpPr>
          <p:spPr>
            <a:xfrm>
              <a:off x="5262880" y="1837131"/>
              <a:ext cx="83312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0679D169-6A39-E92C-7F6D-338E33CD450A}"/>
                </a:ext>
              </a:extLst>
            </p:cNvPr>
            <p:cNvSpPr txBox="1"/>
            <p:nvPr/>
          </p:nvSpPr>
          <p:spPr>
            <a:xfrm>
              <a:off x="5165200" y="1536589"/>
              <a:ext cx="11136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>
                  <a:solidFill>
                    <a:schemeClr val="bg1"/>
                  </a:solidFill>
                </a:rPr>
                <a:t> Axl β-actin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A72308E2-CB0B-76D9-E814-D176CDDA5E9C}"/>
                </a:ext>
              </a:extLst>
            </p:cNvPr>
            <p:cNvCxnSpPr/>
            <p:nvPr/>
          </p:nvCxnSpPr>
          <p:spPr>
            <a:xfrm>
              <a:off x="6154420" y="1837131"/>
              <a:ext cx="83312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E4CB5CF-7F76-CD88-72D7-18A9752D3C32}"/>
                </a:ext>
              </a:extLst>
            </p:cNvPr>
            <p:cNvSpPr txBox="1"/>
            <p:nvPr/>
          </p:nvSpPr>
          <p:spPr>
            <a:xfrm>
              <a:off x="6031919" y="1536589"/>
              <a:ext cx="1168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>
                  <a:solidFill>
                    <a:schemeClr val="bg1"/>
                  </a:solidFill>
                </a:rPr>
                <a:t>Mer β-actin  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45DD389-551A-5CEC-5F54-3D0AD7E6319C}"/>
                </a:ext>
              </a:extLst>
            </p:cNvPr>
            <p:cNvSpPr txBox="1"/>
            <p:nvPr/>
          </p:nvSpPr>
          <p:spPr>
            <a:xfrm>
              <a:off x="7267920" y="1412327"/>
              <a:ext cx="23129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100" b="0" dirty="0">
                  <a:solidFill>
                    <a:schemeClr val="bg1"/>
                  </a:solidFill>
                </a:rPr>
                <a:t>  Mono     </a:t>
              </a:r>
              <a:r>
                <a:rPr lang="en-US" altLang="zh-CN" sz="1100" b="0" dirty="0" err="1">
                  <a:solidFill>
                    <a:schemeClr val="bg1"/>
                  </a:solidFill>
                </a:rPr>
                <a:t>Neut</a:t>
              </a:r>
              <a:r>
                <a:rPr lang="en-US" altLang="zh-CN" sz="1100" b="0" dirty="0">
                  <a:solidFill>
                    <a:schemeClr val="bg1"/>
                  </a:solidFill>
                </a:rPr>
                <a:t>          Mono   </a:t>
              </a:r>
              <a:r>
                <a:rPr lang="en-US" altLang="zh-CN" sz="1100" b="0" dirty="0" err="1">
                  <a:solidFill>
                    <a:schemeClr val="bg1"/>
                  </a:solidFill>
                </a:rPr>
                <a:t>Neut</a:t>
              </a:r>
              <a:r>
                <a:rPr lang="en-US" altLang="zh-CN" sz="1100" b="0" dirty="0">
                  <a:solidFill>
                    <a:schemeClr val="bg1"/>
                  </a:solidFill>
                </a:rPr>
                <a:t>         </a:t>
              </a:r>
              <a:endParaRPr lang="zh-CN" altLang="en-US" sz="1100" b="0" dirty="0">
                <a:solidFill>
                  <a:schemeClr val="bg1"/>
                </a:solidFill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10FC4C8C-B86F-6D5F-9A9F-919A2CB17787}"/>
                </a:ext>
              </a:extLst>
            </p:cNvPr>
            <p:cNvCxnSpPr/>
            <p:nvPr/>
          </p:nvCxnSpPr>
          <p:spPr>
            <a:xfrm>
              <a:off x="7934960" y="1412327"/>
              <a:ext cx="0" cy="1026073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B5E397DA-369A-E6E6-D92D-51C8FA676672}"/>
                </a:ext>
              </a:extLst>
            </p:cNvPr>
            <p:cNvCxnSpPr/>
            <p:nvPr/>
          </p:nvCxnSpPr>
          <p:spPr>
            <a:xfrm>
              <a:off x="9062720" y="1355836"/>
              <a:ext cx="0" cy="1026073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F214C85A-3A7A-4E58-1ACE-F8F47770CD8D}"/>
                </a:ext>
              </a:extLst>
            </p:cNvPr>
            <p:cNvCxnSpPr/>
            <p:nvPr/>
          </p:nvCxnSpPr>
          <p:spPr>
            <a:xfrm>
              <a:off x="8905240" y="4357452"/>
              <a:ext cx="0" cy="1026073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DA1FC81-9A24-26DA-0B8C-7A0E6EBA90C0}"/>
                </a:ext>
              </a:extLst>
            </p:cNvPr>
            <p:cNvSpPr txBox="1"/>
            <p:nvPr/>
          </p:nvSpPr>
          <p:spPr>
            <a:xfrm>
              <a:off x="8292319" y="4307839"/>
              <a:ext cx="13495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100" b="0" dirty="0">
                  <a:solidFill>
                    <a:schemeClr val="bg1"/>
                  </a:solidFill>
                </a:rPr>
                <a:t>  Mono     </a:t>
              </a:r>
              <a:r>
                <a:rPr lang="en-US" altLang="zh-CN" sz="1100" b="0" dirty="0" err="1">
                  <a:solidFill>
                    <a:schemeClr val="bg1"/>
                  </a:solidFill>
                </a:rPr>
                <a:t>Neut</a:t>
              </a:r>
              <a:r>
                <a:rPr lang="en-US" altLang="zh-CN" sz="1100" b="0" dirty="0">
                  <a:solidFill>
                    <a:schemeClr val="bg1"/>
                  </a:solidFill>
                </a:rPr>
                <a:t>              </a:t>
              </a:r>
              <a:endParaRPr lang="zh-CN" altLang="en-US" sz="1100" b="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68412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85</Words>
  <Application>Microsoft Macintosh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何 超</dc:creator>
  <cp:lastModifiedBy>Microsoft Office User</cp:lastModifiedBy>
  <cp:revision>7</cp:revision>
  <dcterms:created xsi:type="dcterms:W3CDTF">2023-04-16T06:30:46Z</dcterms:created>
  <dcterms:modified xsi:type="dcterms:W3CDTF">2023-04-17T16:59:27Z</dcterms:modified>
</cp:coreProperties>
</file>